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2859088" cy="2859088"/>
  <p:notesSz cx="6858000" cy="9144000"/>
  <p:defaultTextStyle>
    <a:defPPr>
      <a:defRPr lang="ja-JP"/>
    </a:defPPr>
    <a:lvl1pPr marL="0" algn="l" defTabSz="326715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1pPr>
    <a:lvl2pPr marL="163358" algn="l" defTabSz="326715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2pPr>
    <a:lvl3pPr marL="326715" algn="l" defTabSz="326715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3pPr>
    <a:lvl4pPr marL="490073" algn="l" defTabSz="326715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4pPr>
    <a:lvl5pPr marL="653430" algn="l" defTabSz="326715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5pPr>
    <a:lvl6pPr marL="816788" algn="l" defTabSz="326715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6pPr>
    <a:lvl7pPr marL="980145" algn="l" defTabSz="326715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7pPr>
    <a:lvl8pPr marL="1143503" algn="l" defTabSz="326715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8pPr>
    <a:lvl9pPr marL="1306860" algn="l" defTabSz="326715" rtl="0" eaLnBrk="1" latinLnBrk="0" hangingPunct="1">
      <a:defRPr kumimoji="1" sz="6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01">
          <p15:clr>
            <a:srgbClr val="A4A3A4"/>
          </p15:clr>
        </p15:guide>
        <p15:guide id="2" pos="90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358" d="100"/>
          <a:sy n="358" d="100"/>
        </p:scale>
        <p:origin x="3906" y="324"/>
      </p:cViewPr>
      <p:guideLst>
        <p:guide orient="horz" pos="901"/>
        <p:guide pos="90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enichiro\Documents\2015.8.2&#20197;&#21069;&#12398;&#12501;&#12449;&#12452;&#12523;\2014.7.8%20dynabook%20data(3&#21092;&#20341;&#29992;&#12398;&#12487;&#12540;&#12479;&#12354;&#12426;)\Documents\&#23455;&#39443;&#12501;&#12449;&#12452;&#12523;&#65288;2014.3.16&#20197;&#38477;&#12289;VAIO&#12364;&#35519;&#23376;&#24746;&#12356;&#12383;&#12417;&#65289;\3&#21092;&#20341;&#29992;&#38306;&#36899;&#12487;&#12540;&#12479;\&#12476;&#12494;&#12464;&#12521;&#12501;&#12488;&#28204;&#23450;&#12487;&#12540;&#12479;\&#12467;&#12500;&#12540;Xenograft%20model%20&#35251;&#23519;&#12501;&#12449;&#12452;&#12523;%20RPC-9%20Xeno%202016.1.24&#12288;2&#21092;&#36861;&#21152;&#27604;&#36611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enichiro\Documents\2015.8.2&#20197;&#21069;&#12398;&#12501;&#12449;&#12452;&#12523;\2014.7.8%20dynabook%20data(3&#21092;&#20341;&#29992;&#12398;&#12487;&#12540;&#12479;&#12354;&#12426;)\Documents\&#23455;&#39443;&#12501;&#12449;&#12452;&#12523;&#65288;2014.3.16&#20197;&#38477;&#12289;VAIO&#12364;&#35519;&#23376;&#24746;&#12356;&#12383;&#12417;&#65289;\3&#21092;&#20341;&#29992;&#38306;&#36899;&#12487;&#12540;&#12479;\&#12476;&#12494;&#12464;&#12521;&#12501;&#12488;&#28204;&#23450;&#12487;&#12540;&#12479;\&#12467;&#12500;&#12540;Xenograft%20model%20&#35251;&#23519;&#12501;&#12449;&#12452;&#12523;%20RPC-9%20Xeno%202016.1.24&#12288;2&#21092;&#36861;&#21152;&#27604;&#36611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098738090548989"/>
          <c:y val="5.291898481059025E-2"/>
          <c:w val="0.73418416317093393"/>
          <c:h val="0.82767496044268163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D$188</c:f>
              <c:strCache>
                <c:ptCount val="1"/>
                <c:pt idx="0">
                  <c:v>Vehicle</c:v>
                </c:pt>
              </c:strCache>
            </c:strRef>
          </c:tx>
          <c:spPr>
            <a:ln w="9525" cmpd="sng">
              <a:solidFill>
                <a:schemeClr val="tx1"/>
              </a:solidFill>
            </a:ln>
          </c:spPr>
          <c:marker>
            <c:spPr>
              <a:noFill/>
              <a:ln>
                <a:noFill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1!$E$193:$U$193</c:f>
                <c:numCache>
                  <c:formatCode>General</c:formatCode>
                  <c:ptCount val="17"/>
                  <c:pt idx="0">
                    <c:v>79.718704761500973</c:v>
                  </c:pt>
                  <c:pt idx="1">
                    <c:v>86.987569900560459</c:v>
                  </c:pt>
                  <c:pt idx="2">
                    <c:v>108.51543967728982</c:v>
                  </c:pt>
                  <c:pt idx="3">
                    <c:v>122.30891607311933</c:v>
                  </c:pt>
                  <c:pt idx="4">
                    <c:v>170.12065396733763</c:v>
                  </c:pt>
                  <c:pt idx="5">
                    <c:v>182.02748403100878</c:v>
                  </c:pt>
                  <c:pt idx="6">
                    <c:v>214.24726983937063</c:v>
                  </c:pt>
                  <c:pt idx="7">
                    <c:v>213.93975701782821</c:v>
                  </c:pt>
                  <c:pt idx="8">
                    <c:v>248.59623658389054</c:v>
                  </c:pt>
                  <c:pt idx="9">
                    <c:v>244.09543898293325</c:v>
                  </c:pt>
                  <c:pt idx="10">
                    <c:v>256.80777955704787</c:v>
                  </c:pt>
                  <c:pt idx="11">
                    <c:v>284.40566959710878</c:v>
                  </c:pt>
                  <c:pt idx="12">
                    <c:v>279.75467350994938</c:v>
                  </c:pt>
                  <c:pt idx="13">
                    <c:v>325.88434066218758</c:v>
                  </c:pt>
                  <c:pt idx="14">
                    <c:v>343.56216398730078</c:v>
                  </c:pt>
                  <c:pt idx="15">
                    <c:v>344.77503349445817</c:v>
                  </c:pt>
                  <c:pt idx="16">
                    <c:v>385.6244255358063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Sheet1!$E$187:$U$187</c:f>
              <c:numCache>
                <c:formatCode>General</c:formatCode>
                <c:ptCount val="17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  <c:pt idx="10">
                  <c:v>35</c:v>
                </c:pt>
                <c:pt idx="11">
                  <c:v>39</c:v>
                </c:pt>
                <c:pt idx="12">
                  <c:v>42</c:v>
                </c:pt>
                <c:pt idx="13">
                  <c:v>46</c:v>
                </c:pt>
                <c:pt idx="14">
                  <c:v>49</c:v>
                </c:pt>
                <c:pt idx="15">
                  <c:v>53</c:v>
                </c:pt>
                <c:pt idx="16">
                  <c:v>56</c:v>
                </c:pt>
              </c:numCache>
            </c:numRef>
          </c:xVal>
          <c:yVal>
            <c:numRef>
              <c:f>Sheet1!$E$188:$U$188</c:f>
              <c:numCache>
                <c:formatCode>General</c:formatCode>
                <c:ptCount val="17"/>
                <c:pt idx="0">
                  <c:v>194.90517716666668</c:v>
                </c:pt>
                <c:pt idx="1">
                  <c:v>214.25786041666663</c:v>
                </c:pt>
                <c:pt idx="2">
                  <c:v>273.206301</c:v>
                </c:pt>
                <c:pt idx="3">
                  <c:v>307.54452624999993</c:v>
                </c:pt>
                <c:pt idx="4">
                  <c:v>397.74141966666662</c:v>
                </c:pt>
                <c:pt idx="5">
                  <c:v>422.99611125000001</c:v>
                </c:pt>
                <c:pt idx="6">
                  <c:v>469.5928448333334</c:v>
                </c:pt>
                <c:pt idx="7">
                  <c:v>480.32121566666666</c:v>
                </c:pt>
                <c:pt idx="8">
                  <c:v>537.07525525000017</c:v>
                </c:pt>
                <c:pt idx="9">
                  <c:v>554.62573325000005</c:v>
                </c:pt>
                <c:pt idx="10">
                  <c:v>570.31648316666667</c:v>
                </c:pt>
                <c:pt idx="11">
                  <c:v>613.35411349999993</c:v>
                </c:pt>
                <c:pt idx="12">
                  <c:v>617.98773249999988</c:v>
                </c:pt>
                <c:pt idx="13">
                  <c:v>691.07026233333329</c:v>
                </c:pt>
                <c:pt idx="14">
                  <c:v>706.86967466666681</c:v>
                </c:pt>
                <c:pt idx="15">
                  <c:v>744.71812808333323</c:v>
                </c:pt>
                <c:pt idx="16">
                  <c:v>810.19061308333323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heet1!$D$189</c:f>
              <c:strCache>
                <c:ptCount val="1"/>
                <c:pt idx="0">
                  <c:v>Osimertinib</c:v>
                </c:pt>
              </c:strCache>
            </c:strRef>
          </c:tx>
          <c:spPr>
            <a:ln w="12700">
              <a:solidFill>
                <a:srgbClr val="0070C0"/>
              </a:solidFill>
              <a:prstDash val="solid"/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E$194:$U$194</c:f>
                <c:numCache>
                  <c:formatCode>General</c:formatCode>
                  <c:ptCount val="17"/>
                  <c:pt idx="0">
                    <c:v>29.563916525055362</c:v>
                  </c:pt>
                  <c:pt idx="1">
                    <c:v>30.020273276249629</c:v>
                  </c:pt>
                  <c:pt idx="2">
                    <c:v>12.924171381949114</c:v>
                  </c:pt>
                  <c:pt idx="3">
                    <c:v>8.7879900919632146</c:v>
                  </c:pt>
                  <c:pt idx="4">
                    <c:v>7.6917596562649262</c:v>
                  </c:pt>
                  <c:pt idx="5">
                    <c:v>8.1360884690384641</c:v>
                  </c:pt>
                  <c:pt idx="6">
                    <c:v>7.7875948501910734</c:v>
                  </c:pt>
                  <c:pt idx="7">
                    <c:v>8.8304149471225806</c:v>
                  </c:pt>
                  <c:pt idx="8">
                    <c:v>7.5702957229814123</c:v>
                  </c:pt>
                  <c:pt idx="9">
                    <c:v>11.402153135390725</c:v>
                  </c:pt>
                  <c:pt idx="10">
                    <c:v>22.138405402270148</c:v>
                  </c:pt>
                  <c:pt idx="11">
                    <c:v>30.705619562148346</c:v>
                  </c:pt>
                  <c:pt idx="12">
                    <c:v>43.711929735703968</c:v>
                  </c:pt>
                  <c:pt idx="13">
                    <c:v>58.516811376704261</c:v>
                  </c:pt>
                  <c:pt idx="14">
                    <c:v>71.994849403717424</c:v>
                  </c:pt>
                  <c:pt idx="15">
                    <c:v>88.695799991354534</c:v>
                  </c:pt>
                  <c:pt idx="16">
                    <c:v>106.34144529024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Sheet1!$E$187:$U$187</c:f>
              <c:numCache>
                <c:formatCode>General</c:formatCode>
                <c:ptCount val="17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  <c:pt idx="10">
                  <c:v>35</c:v>
                </c:pt>
                <c:pt idx="11">
                  <c:v>39</c:v>
                </c:pt>
                <c:pt idx="12">
                  <c:v>42</c:v>
                </c:pt>
                <c:pt idx="13">
                  <c:v>46</c:v>
                </c:pt>
                <c:pt idx="14">
                  <c:v>49</c:v>
                </c:pt>
                <c:pt idx="15">
                  <c:v>53</c:v>
                </c:pt>
                <c:pt idx="16">
                  <c:v>56</c:v>
                </c:pt>
              </c:numCache>
            </c:numRef>
          </c:xVal>
          <c:yVal>
            <c:numRef>
              <c:f>Sheet1!$E$189:$U$189</c:f>
              <c:numCache>
                <c:formatCode>General</c:formatCode>
                <c:ptCount val="17"/>
                <c:pt idx="0">
                  <c:v>204.53393906249997</c:v>
                </c:pt>
                <c:pt idx="1">
                  <c:v>177.34556187500002</c:v>
                </c:pt>
                <c:pt idx="2">
                  <c:v>117.386129</c:v>
                </c:pt>
                <c:pt idx="3">
                  <c:v>66.625743749999998</c:v>
                </c:pt>
                <c:pt idx="4">
                  <c:v>56.432688312499998</c:v>
                </c:pt>
                <c:pt idx="5">
                  <c:v>61.263628875000009</c:v>
                </c:pt>
                <c:pt idx="6">
                  <c:v>57.813682124999993</c:v>
                </c:pt>
                <c:pt idx="7">
                  <c:v>52.111134687500005</c:v>
                </c:pt>
                <c:pt idx="8">
                  <c:v>44.943825500000003</c:v>
                </c:pt>
                <c:pt idx="9">
                  <c:v>75.285784812499998</c:v>
                </c:pt>
                <c:pt idx="10">
                  <c:v>130.73706299999998</c:v>
                </c:pt>
                <c:pt idx="11">
                  <c:v>170.06058637499999</c:v>
                </c:pt>
                <c:pt idx="12">
                  <c:v>219.55251418749998</c:v>
                </c:pt>
                <c:pt idx="13">
                  <c:v>276.91619850000001</c:v>
                </c:pt>
                <c:pt idx="14">
                  <c:v>345.71614262499997</c:v>
                </c:pt>
                <c:pt idx="15">
                  <c:v>441.57862562500003</c:v>
                </c:pt>
                <c:pt idx="16">
                  <c:v>509.66263175000006</c:v>
                </c:pt>
              </c:numCache>
            </c:numRef>
          </c:yVal>
          <c:smooth val="0"/>
        </c:ser>
        <c:ser>
          <c:idx val="3"/>
          <c:order val="2"/>
          <c:tx>
            <c:strRef>
              <c:f>Sheet1!$D$191</c:f>
              <c:strCache>
                <c:ptCount val="1"/>
                <c:pt idx="0">
                  <c:v>Osimertinib/bev</c:v>
                </c:pt>
              </c:strCache>
            </c:strRef>
          </c:tx>
          <c:spPr>
            <a:ln w="12700">
              <a:solidFill>
                <a:srgbClr val="C00000"/>
              </a:solidFill>
              <a:prstDash val="sysDot"/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E$196:$U$196</c:f>
                <c:numCache>
                  <c:formatCode>General</c:formatCode>
                  <c:ptCount val="17"/>
                  <c:pt idx="0">
                    <c:v>23.152481433063251</c:v>
                  </c:pt>
                  <c:pt idx="1">
                    <c:v>19.010448574335154</c:v>
                  </c:pt>
                  <c:pt idx="2">
                    <c:v>10.763335830843658</c:v>
                  </c:pt>
                  <c:pt idx="3">
                    <c:v>9.9245166985495388</c:v>
                  </c:pt>
                  <c:pt idx="4">
                    <c:v>12.919530408443116</c:v>
                  </c:pt>
                  <c:pt idx="5">
                    <c:v>12.643099374577362</c:v>
                  </c:pt>
                  <c:pt idx="6">
                    <c:v>10.992765101409375</c:v>
                  </c:pt>
                  <c:pt idx="7">
                    <c:v>12.585683320855756</c:v>
                  </c:pt>
                  <c:pt idx="8">
                    <c:v>9.033677358769129</c:v>
                  </c:pt>
                  <c:pt idx="9">
                    <c:v>19.233029753363301</c:v>
                  </c:pt>
                  <c:pt idx="10">
                    <c:v>27.755490444601772</c:v>
                  </c:pt>
                  <c:pt idx="11">
                    <c:v>37.233492178058555</c:v>
                  </c:pt>
                  <c:pt idx="12">
                    <c:v>50.311879276448529</c:v>
                  </c:pt>
                  <c:pt idx="13">
                    <c:v>68.287733067551784</c:v>
                  </c:pt>
                  <c:pt idx="14">
                    <c:v>82.250219226528188</c:v>
                  </c:pt>
                  <c:pt idx="15">
                    <c:v>107.17381260258277</c:v>
                  </c:pt>
                  <c:pt idx="16">
                    <c:v>110.3126767908384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Sheet1!$E$187:$U$187</c:f>
              <c:numCache>
                <c:formatCode>General</c:formatCode>
                <c:ptCount val="17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  <c:pt idx="10">
                  <c:v>35</c:v>
                </c:pt>
                <c:pt idx="11">
                  <c:v>39</c:v>
                </c:pt>
                <c:pt idx="12">
                  <c:v>42</c:v>
                </c:pt>
                <c:pt idx="13">
                  <c:v>46</c:v>
                </c:pt>
                <c:pt idx="14">
                  <c:v>49</c:v>
                </c:pt>
                <c:pt idx="15">
                  <c:v>53</c:v>
                </c:pt>
                <c:pt idx="16">
                  <c:v>56</c:v>
                </c:pt>
              </c:numCache>
            </c:numRef>
          </c:xVal>
          <c:yVal>
            <c:numRef>
              <c:f>Sheet1!$E$191:$U$191</c:f>
              <c:numCache>
                <c:formatCode>General</c:formatCode>
                <c:ptCount val="17"/>
                <c:pt idx="0">
                  <c:v>188.5271669375</c:v>
                </c:pt>
                <c:pt idx="1">
                  <c:v>119.73228349999999</c:v>
                </c:pt>
                <c:pt idx="2">
                  <c:v>66.292595375000005</c:v>
                </c:pt>
                <c:pt idx="3">
                  <c:v>41.447521374999994</c:v>
                </c:pt>
                <c:pt idx="4">
                  <c:v>34.909353312499995</c:v>
                </c:pt>
                <c:pt idx="5">
                  <c:v>40.713916187499997</c:v>
                </c:pt>
                <c:pt idx="6">
                  <c:v>34.114293937500001</c:v>
                </c:pt>
                <c:pt idx="7">
                  <c:v>35.312572125000003</c:v>
                </c:pt>
                <c:pt idx="8">
                  <c:v>26.575610187500004</c:v>
                </c:pt>
                <c:pt idx="9">
                  <c:v>56.200982500000002</c:v>
                </c:pt>
                <c:pt idx="10">
                  <c:v>78.485299562500003</c:v>
                </c:pt>
                <c:pt idx="11">
                  <c:v>109.25638781249999</c:v>
                </c:pt>
                <c:pt idx="12">
                  <c:v>142.67950987500001</c:v>
                </c:pt>
                <c:pt idx="13">
                  <c:v>188.59984499999999</c:v>
                </c:pt>
                <c:pt idx="14">
                  <c:v>250.5395494375</c:v>
                </c:pt>
                <c:pt idx="15">
                  <c:v>338.6073061875</c:v>
                </c:pt>
                <c:pt idx="16">
                  <c:v>363.946830062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577294336"/>
        <c:axId val="-577297056"/>
      </c:scatterChart>
      <c:valAx>
        <c:axId val="-577294336"/>
        <c:scaling>
          <c:orientation val="minMax"/>
          <c:max val="5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 b="1"/>
            </a:pPr>
            <a:endParaRPr lang="ja-JP"/>
          </a:p>
        </c:txPr>
        <c:crossAx val="-577297056"/>
        <c:crosses val="autoZero"/>
        <c:crossBetween val="midCat"/>
        <c:majorUnit val="7"/>
      </c:valAx>
      <c:valAx>
        <c:axId val="-577297056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 b="1"/>
            </a:pPr>
            <a:endParaRPr lang="ja-JP"/>
          </a:p>
        </c:txPr>
        <c:crossAx val="-57729433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3245952948615722"/>
          <c:y val="2.9058188247357144E-2"/>
          <c:w val="0.57716838636937584"/>
          <c:h val="0.29569190079265578"/>
        </c:manualLayout>
      </c:layout>
      <c:overlay val="0"/>
      <c:txPr>
        <a:bodyPr/>
        <a:lstStyle/>
        <a:p>
          <a:pPr>
            <a:defRPr sz="800" b="1"/>
          </a:pPr>
          <a:endParaRPr lang="ja-JP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357709296668187"/>
          <c:y val="5.1410582415040464E-2"/>
          <c:w val="0.89688247979063884"/>
          <c:h val="0.82927197469186575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D$202</c:f>
              <c:strCache>
                <c:ptCount val="1"/>
                <c:pt idx="0">
                  <c:v>Vehicle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Sheet1!$E$201:$U$201</c:f>
              <c:numCache>
                <c:formatCode>General</c:formatCode>
                <c:ptCount val="17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  <c:pt idx="10">
                  <c:v>35</c:v>
                </c:pt>
                <c:pt idx="11">
                  <c:v>39</c:v>
                </c:pt>
                <c:pt idx="12">
                  <c:v>42</c:v>
                </c:pt>
                <c:pt idx="13">
                  <c:v>46</c:v>
                </c:pt>
                <c:pt idx="14">
                  <c:v>49</c:v>
                </c:pt>
                <c:pt idx="15">
                  <c:v>53</c:v>
                </c:pt>
                <c:pt idx="16">
                  <c:v>56</c:v>
                </c:pt>
              </c:numCache>
            </c:numRef>
          </c:xVal>
          <c:yVal>
            <c:numRef>
              <c:f>Sheet1!$E$202:$U$202</c:f>
              <c:numCache>
                <c:formatCode>General</c:formatCode>
                <c:ptCount val="17"/>
                <c:pt idx="0">
                  <c:v>20.666666666666668</c:v>
                </c:pt>
                <c:pt idx="1">
                  <c:v>19.933333333333334</c:v>
                </c:pt>
                <c:pt idx="2">
                  <c:v>20.766666666666666</c:v>
                </c:pt>
                <c:pt idx="3">
                  <c:v>20.133333333333333</c:v>
                </c:pt>
                <c:pt idx="4">
                  <c:v>20.233333333333334</c:v>
                </c:pt>
                <c:pt idx="5">
                  <c:v>20.166666666666668</c:v>
                </c:pt>
                <c:pt idx="6">
                  <c:v>20.466666666666665</c:v>
                </c:pt>
                <c:pt idx="7">
                  <c:v>20.566666666666666</c:v>
                </c:pt>
                <c:pt idx="8">
                  <c:v>20</c:v>
                </c:pt>
                <c:pt idx="9">
                  <c:v>20.366666666666667</c:v>
                </c:pt>
                <c:pt idx="10">
                  <c:v>21.233333333333334</c:v>
                </c:pt>
                <c:pt idx="11">
                  <c:v>20.633333333333329</c:v>
                </c:pt>
                <c:pt idx="12">
                  <c:v>21.533333333333335</c:v>
                </c:pt>
                <c:pt idx="13">
                  <c:v>21.533333333333331</c:v>
                </c:pt>
                <c:pt idx="14">
                  <c:v>21.566666666666666</c:v>
                </c:pt>
                <c:pt idx="15">
                  <c:v>21.966666666666665</c:v>
                </c:pt>
                <c:pt idx="16">
                  <c:v>22.366666666666664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heet1!$D$203</c:f>
              <c:strCache>
                <c:ptCount val="1"/>
                <c:pt idx="0">
                  <c:v>Osimertinib</c:v>
                </c:pt>
              </c:strCache>
            </c:strRef>
          </c:tx>
          <c:spPr>
            <a:ln w="12700">
              <a:solidFill>
                <a:srgbClr val="0070C0"/>
              </a:solidFill>
              <a:prstDash val="solid"/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E$208:$U$208</c:f>
                <c:numCache>
                  <c:formatCode>General</c:formatCode>
                  <c:ptCount val="17"/>
                  <c:pt idx="0">
                    <c:v>0.65239941753499442</c:v>
                  </c:pt>
                  <c:pt idx="1">
                    <c:v>0.65875513913238959</c:v>
                  </c:pt>
                  <c:pt idx="2">
                    <c:v>0.62633191413711842</c:v>
                  </c:pt>
                  <c:pt idx="3">
                    <c:v>0.4346933785248327</c:v>
                  </c:pt>
                  <c:pt idx="4">
                    <c:v>0.30652623596249218</c:v>
                  </c:pt>
                  <c:pt idx="5">
                    <c:v>0.4546060565661949</c:v>
                  </c:pt>
                  <c:pt idx="6">
                    <c:v>0.3772156765918761</c:v>
                  </c:pt>
                  <c:pt idx="7">
                    <c:v>0.52121652570372967</c:v>
                  </c:pt>
                  <c:pt idx="8">
                    <c:v>0.44976845895045486</c:v>
                  </c:pt>
                  <c:pt idx="9">
                    <c:v>0.46278144589716053</c:v>
                  </c:pt>
                  <c:pt idx="10">
                    <c:v>0.32242570203588472</c:v>
                  </c:pt>
                  <c:pt idx="11">
                    <c:v>0.41932485418030446</c:v>
                  </c:pt>
                  <c:pt idx="12">
                    <c:v>0.67004353092417301</c:v>
                  </c:pt>
                  <c:pt idx="13">
                    <c:v>0.53619026473818088</c:v>
                  </c:pt>
                  <c:pt idx="14">
                    <c:v>0.56050572402667509</c:v>
                  </c:pt>
                  <c:pt idx="15">
                    <c:v>0.37416573867739428</c:v>
                  </c:pt>
                  <c:pt idx="16">
                    <c:v>0.5979130371550703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Sheet1!$E$201:$U$201</c:f>
              <c:numCache>
                <c:formatCode>General</c:formatCode>
                <c:ptCount val="17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  <c:pt idx="10">
                  <c:v>35</c:v>
                </c:pt>
                <c:pt idx="11">
                  <c:v>39</c:v>
                </c:pt>
                <c:pt idx="12">
                  <c:v>42</c:v>
                </c:pt>
                <c:pt idx="13">
                  <c:v>46</c:v>
                </c:pt>
                <c:pt idx="14">
                  <c:v>49</c:v>
                </c:pt>
                <c:pt idx="15">
                  <c:v>53</c:v>
                </c:pt>
                <c:pt idx="16">
                  <c:v>56</c:v>
                </c:pt>
              </c:numCache>
            </c:numRef>
          </c:xVal>
          <c:yVal>
            <c:numRef>
              <c:f>Sheet1!$E$203:$U$203</c:f>
              <c:numCache>
                <c:formatCode>General</c:formatCode>
                <c:ptCount val="17"/>
                <c:pt idx="0">
                  <c:v>20.375</c:v>
                </c:pt>
                <c:pt idx="1">
                  <c:v>20.875</c:v>
                </c:pt>
                <c:pt idx="2">
                  <c:v>20.625</c:v>
                </c:pt>
                <c:pt idx="3">
                  <c:v>20.324999999999999</c:v>
                </c:pt>
                <c:pt idx="4">
                  <c:v>20.725000000000001</c:v>
                </c:pt>
                <c:pt idx="5">
                  <c:v>20.7</c:v>
                </c:pt>
                <c:pt idx="6">
                  <c:v>19.825000000000003</c:v>
                </c:pt>
                <c:pt idx="7">
                  <c:v>20.3</c:v>
                </c:pt>
                <c:pt idx="8">
                  <c:v>20.175000000000001</c:v>
                </c:pt>
                <c:pt idx="9">
                  <c:v>20.65</c:v>
                </c:pt>
                <c:pt idx="10">
                  <c:v>21.125</c:v>
                </c:pt>
                <c:pt idx="11">
                  <c:v>20.149999999999999</c:v>
                </c:pt>
                <c:pt idx="12">
                  <c:v>20.875000000000004</c:v>
                </c:pt>
                <c:pt idx="13">
                  <c:v>20.65</c:v>
                </c:pt>
                <c:pt idx="14">
                  <c:v>21.25</c:v>
                </c:pt>
                <c:pt idx="15">
                  <c:v>21.3</c:v>
                </c:pt>
                <c:pt idx="16">
                  <c:v>21.55</c:v>
                </c:pt>
              </c:numCache>
            </c:numRef>
          </c:yVal>
          <c:smooth val="0"/>
        </c:ser>
        <c:ser>
          <c:idx val="3"/>
          <c:order val="2"/>
          <c:tx>
            <c:strRef>
              <c:f>Sheet1!$D$205</c:f>
              <c:strCache>
                <c:ptCount val="1"/>
                <c:pt idx="0">
                  <c:v>Osimertinib/bev</c:v>
                </c:pt>
              </c:strCache>
            </c:strRef>
          </c:tx>
          <c:spPr>
            <a:ln w="12700">
              <a:solidFill>
                <a:srgbClr val="C00000"/>
              </a:solidFill>
              <a:prstDash val="sysDot"/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Sheet1!$E$210:$U$210</c:f>
                <c:numCache>
                  <c:formatCode>General</c:formatCode>
                  <c:ptCount val="17"/>
                  <c:pt idx="0">
                    <c:v>0.37052890125692844</c:v>
                  </c:pt>
                  <c:pt idx="1">
                    <c:v>0.38622100754188249</c:v>
                  </c:pt>
                  <c:pt idx="2">
                    <c:v>0.28099525500145645</c:v>
                  </c:pt>
                  <c:pt idx="3">
                    <c:v>0.48541219597368973</c:v>
                  </c:pt>
                  <c:pt idx="4">
                    <c:v>0.44604745636908799</c:v>
                  </c:pt>
                  <c:pt idx="5">
                    <c:v>0.46278144589716025</c:v>
                  </c:pt>
                  <c:pt idx="6">
                    <c:v>0.44604745636908738</c:v>
                  </c:pt>
                  <c:pt idx="7">
                    <c:v>0.50228643886398827</c:v>
                  </c:pt>
                  <c:pt idx="8">
                    <c:v>0.5452445934318525</c:v>
                  </c:pt>
                  <c:pt idx="9">
                    <c:v>0.44791182167922283</c:v>
                  </c:pt>
                  <c:pt idx="10">
                    <c:v>0.61913918736689066</c:v>
                  </c:pt>
                  <c:pt idx="11">
                    <c:v>0.44976845895045459</c:v>
                  </c:pt>
                  <c:pt idx="12">
                    <c:v>0.49413223601245376</c:v>
                  </c:pt>
                  <c:pt idx="13">
                    <c:v>0.40926763859362225</c:v>
                  </c:pt>
                  <c:pt idx="14">
                    <c:v>0.23935677693908461</c:v>
                  </c:pt>
                  <c:pt idx="15">
                    <c:v>0.17969882210706528</c:v>
                  </c:pt>
                  <c:pt idx="16">
                    <c:v>0.2462214450449030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xVal>
            <c:numRef>
              <c:f>Sheet1!$E$201:$U$201</c:f>
              <c:numCache>
                <c:formatCode>General</c:formatCode>
                <c:ptCount val="17"/>
                <c:pt idx="0">
                  <c:v>0</c:v>
                </c:pt>
                <c:pt idx="1">
                  <c:v>4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8</c:v>
                </c:pt>
                <c:pt idx="6">
                  <c:v>21</c:v>
                </c:pt>
                <c:pt idx="7">
                  <c:v>25</c:v>
                </c:pt>
                <c:pt idx="8">
                  <c:v>28</c:v>
                </c:pt>
                <c:pt idx="9">
                  <c:v>32</c:v>
                </c:pt>
                <c:pt idx="10">
                  <c:v>35</c:v>
                </c:pt>
                <c:pt idx="11">
                  <c:v>39</c:v>
                </c:pt>
                <c:pt idx="12">
                  <c:v>42</c:v>
                </c:pt>
                <c:pt idx="13">
                  <c:v>46</c:v>
                </c:pt>
                <c:pt idx="14">
                  <c:v>49</c:v>
                </c:pt>
                <c:pt idx="15">
                  <c:v>53</c:v>
                </c:pt>
                <c:pt idx="16">
                  <c:v>56</c:v>
                </c:pt>
              </c:numCache>
            </c:numRef>
          </c:xVal>
          <c:yVal>
            <c:numRef>
              <c:f>Sheet1!$E$205:$U$205</c:f>
              <c:numCache>
                <c:formatCode>General</c:formatCode>
                <c:ptCount val="17"/>
                <c:pt idx="0">
                  <c:v>21.175000000000001</c:v>
                </c:pt>
                <c:pt idx="1">
                  <c:v>21.950000000000003</c:v>
                </c:pt>
                <c:pt idx="2">
                  <c:v>21.824999999999999</c:v>
                </c:pt>
                <c:pt idx="3">
                  <c:v>21.725000000000001</c:v>
                </c:pt>
                <c:pt idx="4">
                  <c:v>21.575000000000003</c:v>
                </c:pt>
                <c:pt idx="5">
                  <c:v>21.35</c:v>
                </c:pt>
                <c:pt idx="6">
                  <c:v>21.575000000000003</c:v>
                </c:pt>
                <c:pt idx="7">
                  <c:v>22.125</c:v>
                </c:pt>
                <c:pt idx="8">
                  <c:v>21.024999999999999</c:v>
                </c:pt>
                <c:pt idx="9">
                  <c:v>21.725000000000001</c:v>
                </c:pt>
                <c:pt idx="10">
                  <c:v>22.6</c:v>
                </c:pt>
                <c:pt idx="11">
                  <c:v>22.725000000000001</c:v>
                </c:pt>
                <c:pt idx="12">
                  <c:v>22.65</c:v>
                </c:pt>
                <c:pt idx="13">
                  <c:v>22.75</c:v>
                </c:pt>
                <c:pt idx="14">
                  <c:v>22.824999999999999</c:v>
                </c:pt>
                <c:pt idx="15">
                  <c:v>23.525000000000002</c:v>
                </c:pt>
                <c:pt idx="16">
                  <c:v>23.67500000000000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577296512"/>
        <c:axId val="-577293792"/>
      </c:scatterChart>
      <c:valAx>
        <c:axId val="-577296512"/>
        <c:scaling>
          <c:orientation val="minMax"/>
          <c:max val="5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 b="1"/>
            </a:pPr>
            <a:endParaRPr lang="ja-JP"/>
          </a:p>
        </c:txPr>
        <c:crossAx val="-577293792"/>
        <c:crosses val="autoZero"/>
        <c:crossBetween val="midCat"/>
        <c:majorUnit val="7"/>
      </c:valAx>
      <c:valAx>
        <c:axId val="-577293792"/>
        <c:scaling>
          <c:orientation val="minMax"/>
          <c:min val="0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 b="1"/>
            </a:pPr>
            <a:endParaRPr lang="ja-JP"/>
          </a:p>
        </c:txPr>
        <c:crossAx val="-57729651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1251732125498956"/>
          <c:y val="0.37460990906392766"/>
          <c:w val="0.66917592190440733"/>
          <c:h val="0.35790375080888831"/>
        </c:manualLayout>
      </c:layout>
      <c:overlay val="0"/>
      <c:txPr>
        <a:bodyPr/>
        <a:lstStyle/>
        <a:p>
          <a:pPr>
            <a:defRPr sz="800" b="1"/>
          </a:pPr>
          <a:endParaRPr lang="ja-JP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214432" y="888171"/>
            <a:ext cx="2430225" cy="612851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428863" y="1620150"/>
            <a:ext cx="2001362" cy="73065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633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3267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49007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6534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8167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9801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1435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3068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2072839" y="114496"/>
            <a:ext cx="643295" cy="2439490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142954" y="114496"/>
            <a:ext cx="1882233" cy="243949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25848" y="1837229"/>
            <a:ext cx="2430225" cy="567847"/>
          </a:xfrm>
        </p:spPr>
        <p:txBody>
          <a:bodyPr anchor="t"/>
          <a:lstStyle>
            <a:lvl1pPr algn="l">
              <a:defRPr sz="14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225848" y="1211804"/>
            <a:ext cx="2430225" cy="625425"/>
          </a:xfrm>
        </p:spPr>
        <p:txBody>
          <a:bodyPr anchor="b"/>
          <a:lstStyle>
            <a:lvl1pPr marL="0" indent="0">
              <a:buNone/>
              <a:defRPr sz="700">
                <a:solidFill>
                  <a:schemeClr val="tx1">
                    <a:tint val="75000"/>
                  </a:schemeClr>
                </a:solidFill>
              </a:defRPr>
            </a:lvl1pPr>
            <a:lvl2pPr marL="163358" indent="0">
              <a:buNone/>
              <a:defRPr sz="600">
                <a:solidFill>
                  <a:schemeClr val="tx1">
                    <a:tint val="75000"/>
                  </a:schemeClr>
                </a:solidFill>
              </a:defRPr>
            </a:lvl2pPr>
            <a:lvl3pPr marL="326715" indent="0">
              <a:buNone/>
              <a:defRPr sz="600">
                <a:solidFill>
                  <a:schemeClr val="tx1">
                    <a:tint val="75000"/>
                  </a:schemeClr>
                </a:solidFill>
              </a:defRPr>
            </a:lvl3pPr>
            <a:lvl4pPr marL="490073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4pPr>
            <a:lvl5pPr marL="653430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5pPr>
            <a:lvl6pPr marL="816788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6pPr>
            <a:lvl7pPr marL="980145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7pPr>
            <a:lvl8pPr marL="1143503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8pPr>
            <a:lvl9pPr marL="1306860" indent="0">
              <a:buNone/>
              <a:defRPr sz="5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142954" y="667121"/>
            <a:ext cx="1262764" cy="1886866"/>
          </a:xfrm>
        </p:spPr>
        <p:txBody>
          <a:bodyPr/>
          <a:lstStyle>
            <a:lvl1pPr>
              <a:defRPr sz="1000"/>
            </a:lvl1pPr>
            <a:lvl2pPr>
              <a:defRPr sz="900"/>
            </a:lvl2pPr>
            <a:lvl3pPr>
              <a:defRPr sz="700"/>
            </a:lvl3pPr>
            <a:lvl4pPr>
              <a:defRPr sz="600"/>
            </a:lvl4pPr>
            <a:lvl5pPr>
              <a:defRPr sz="600"/>
            </a:lvl5pPr>
            <a:lvl6pPr>
              <a:defRPr sz="600"/>
            </a:lvl6pPr>
            <a:lvl7pPr>
              <a:defRPr sz="600"/>
            </a:lvl7pPr>
            <a:lvl8pPr>
              <a:defRPr sz="600"/>
            </a:lvl8pPr>
            <a:lvl9pPr>
              <a:defRPr sz="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1453370" y="667121"/>
            <a:ext cx="1262764" cy="1886866"/>
          </a:xfrm>
        </p:spPr>
        <p:txBody>
          <a:bodyPr/>
          <a:lstStyle>
            <a:lvl1pPr>
              <a:defRPr sz="1000"/>
            </a:lvl1pPr>
            <a:lvl2pPr>
              <a:defRPr sz="900"/>
            </a:lvl2pPr>
            <a:lvl3pPr>
              <a:defRPr sz="700"/>
            </a:lvl3pPr>
            <a:lvl4pPr>
              <a:defRPr sz="600"/>
            </a:lvl4pPr>
            <a:lvl5pPr>
              <a:defRPr sz="600"/>
            </a:lvl5pPr>
            <a:lvl6pPr>
              <a:defRPr sz="600"/>
            </a:lvl6pPr>
            <a:lvl7pPr>
              <a:defRPr sz="600"/>
            </a:lvl7pPr>
            <a:lvl8pPr>
              <a:defRPr sz="600"/>
            </a:lvl8pPr>
            <a:lvl9pPr>
              <a:defRPr sz="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142955" y="639986"/>
            <a:ext cx="1263260" cy="266716"/>
          </a:xfrm>
        </p:spPr>
        <p:txBody>
          <a:bodyPr anchor="b"/>
          <a:lstStyle>
            <a:lvl1pPr marL="0" indent="0">
              <a:buNone/>
              <a:defRPr sz="900" b="1"/>
            </a:lvl1pPr>
            <a:lvl2pPr marL="163358" indent="0">
              <a:buNone/>
              <a:defRPr sz="700" b="1"/>
            </a:lvl2pPr>
            <a:lvl3pPr marL="326715" indent="0">
              <a:buNone/>
              <a:defRPr sz="600" b="1"/>
            </a:lvl3pPr>
            <a:lvl4pPr marL="490073" indent="0">
              <a:buNone/>
              <a:defRPr sz="600" b="1"/>
            </a:lvl4pPr>
            <a:lvl5pPr marL="653430" indent="0">
              <a:buNone/>
              <a:defRPr sz="600" b="1"/>
            </a:lvl5pPr>
            <a:lvl6pPr marL="816788" indent="0">
              <a:buNone/>
              <a:defRPr sz="600" b="1"/>
            </a:lvl6pPr>
            <a:lvl7pPr marL="980145" indent="0">
              <a:buNone/>
              <a:defRPr sz="600" b="1"/>
            </a:lvl7pPr>
            <a:lvl8pPr marL="1143503" indent="0">
              <a:buNone/>
              <a:defRPr sz="600" b="1"/>
            </a:lvl8pPr>
            <a:lvl9pPr marL="1306860" indent="0">
              <a:buNone/>
              <a:defRPr sz="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142955" y="906701"/>
            <a:ext cx="1263260" cy="1647285"/>
          </a:xfrm>
        </p:spPr>
        <p:txBody>
          <a:bodyPr/>
          <a:lstStyle>
            <a:lvl1pPr>
              <a:defRPr sz="900"/>
            </a:lvl1pPr>
            <a:lvl2pPr>
              <a:defRPr sz="700"/>
            </a:lvl2pPr>
            <a:lvl3pPr>
              <a:defRPr sz="600"/>
            </a:lvl3pPr>
            <a:lvl4pPr>
              <a:defRPr sz="600"/>
            </a:lvl4pPr>
            <a:lvl5pPr>
              <a:defRPr sz="600"/>
            </a:lvl5pPr>
            <a:lvl6pPr>
              <a:defRPr sz="600"/>
            </a:lvl6pPr>
            <a:lvl7pPr>
              <a:defRPr sz="600"/>
            </a:lvl7pPr>
            <a:lvl8pPr>
              <a:defRPr sz="600"/>
            </a:lvl8pPr>
            <a:lvl9pPr>
              <a:defRPr sz="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1452377" y="639986"/>
            <a:ext cx="1263757" cy="266716"/>
          </a:xfrm>
        </p:spPr>
        <p:txBody>
          <a:bodyPr anchor="b"/>
          <a:lstStyle>
            <a:lvl1pPr marL="0" indent="0">
              <a:buNone/>
              <a:defRPr sz="900" b="1"/>
            </a:lvl1pPr>
            <a:lvl2pPr marL="163358" indent="0">
              <a:buNone/>
              <a:defRPr sz="700" b="1"/>
            </a:lvl2pPr>
            <a:lvl3pPr marL="326715" indent="0">
              <a:buNone/>
              <a:defRPr sz="600" b="1"/>
            </a:lvl3pPr>
            <a:lvl4pPr marL="490073" indent="0">
              <a:buNone/>
              <a:defRPr sz="600" b="1"/>
            </a:lvl4pPr>
            <a:lvl5pPr marL="653430" indent="0">
              <a:buNone/>
              <a:defRPr sz="600" b="1"/>
            </a:lvl5pPr>
            <a:lvl6pPr marL="816788" indent="0">
              <a:buNone/>
              <a:defRPr sz="600" b="1"/>
            </a:lvl6pPr>
            <a:lvl7pPr marL="980145" indent="0">
              <a:buNone/>
              <a:defRPr sz="600" b="1"/>
            </a:lvl7pPr>
            <a:lvl8pPr marL="1143503" indent="0">
              <a:buNone/>
              <a:defRPr sz="600" b="1"/>
            </a:lvl8pPr>
            <a:lvl9pPr marL="1306860" indent="0">
              <a:buNone/>
              <a:defRPr sz="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1452377" y="906701"/>
            <a:ext cx="1263757" cy="1647285"/>
          </a:xfrm>
        </p:spPr>
        <p:txBody>
          <a:bodyPr/>
          <a:lstStyle>
            <a:lvl1pPr>
              <a:defRPr sz="900"/>
            </a:lvl1pPr>
            <a:lvl2pPr>
              <a:defRPr sz="700"/>
            </a:lvl2pPr>
            <a:lvl3pPr>
              <a:defRPr sz="600"/>
            </a:lvl3pPr>
            <a:lvl4pPr>
              <a:defRPr sz="600"/>
            </a:lvl4pPr>
            <a:lvl5pPr>
              <a:defRPr sz="600"/>
            </a:lvl5pPr>
            <a:lvl6pPr>
              <a:defRPr sz="600"/>
            </a:lvl6pPr>
            <a:lvl7pPr>
              <a:defRPr sz="600"/>
            </a:lvl7pPr>
            <a:lvl8pPr>
              <a:defRPr sz="600"/>
            </a:lvl8pPr>
            <a:lvl9pPr>
              <a:defRPr sz="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42955" y="113834"/>
            <a:ext cx="940620" cy="484457"/>
          </a:xfrm>
        </p:spPr>
        <p:txBody>
          <a:bodyPr anchor="b"/>
          <a:lstStyle>
            <a:lvl1pPr algn="l">
              <a:defRPr sz="7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1117824" y="113834"/>
            <a:ext cx="1598310" cy="2440152"/>
          </a:xfrm>
        </p:spPr>
        <p:txBody>
          <a:bodyPr/>
          <a:lstStyle>
            <a:lvl1pPr>
              <a:defRPr sz="1100"/>
            </a:lvl1pPr>
            <a:lvl2pPr>
              <a:defRPr sz="1000"/>
            </a:lvl2pPr>
            <a:lvl3pPr>
              <a:defRPr sz="900"/>
            </a:lvl3pPr>
            <a:lvl4pPr>
              <a:defRPr sz="700"/>
            </a:lvl4pPr>
            <a:lvl5pPr>
              <a:defRPr sz="700"/>
            </a:lvl5pPr>
            <a:lvl6pPr>
              <a:defRPr sz="700"/>
            </a:lvl6pPr>
            <a:lvl7pPr>
              <a:defRPr sz="700"/>
            </a:lvl7pPr>
            <a:lvl8pPr>
              <a:defRPr sz="700"/>
            </a:lvl8pPr>
            <a:lvl9pPr>
              <a:defRPr sz="7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42955" y="598291"/>
            <a:ext cx="940620" cy="1955696"/>
          </a:xfrm>
        </p:spPr>
        <p:txBody>
          <a:bodyPr/>
          <a:lstStyle>
            <a:lvl1pPr marL="0" indent="0">
              <a:buNone/>
              <a:defRPr sz="500"/>
            </a:lvl1pPr>
            <a:lvl2pPr marL="163358" indent="0">
              <a:buNone/>
              <a:defRPr sz="400"/>
            </a:lvl2pPr>
            <a:lvl3pPr marL="326715" indent="0">
              <a:buNone/>
              <a:defRPr sz="400"/>
            </a:lvl3pPr>
            <a:lvl4pPr marL="490073" indent="0">
              <a:buNone/>
              <a:defRPr sz="300"/>
            </a:lvl4pPr>
            <a:lvl5pPr marL="653430" indent="0">
              <a:buNone/>
              <a:defRPr sz="300"/>
            </a:lvl5pPr>
            <a:lvl6pPr marL="816788" indent="0">
              <a:buNone/>
              <a:defRPr sz="300"/>
            </a:lvl6pPr>
            <a:lvl7pPr marL="980145" indent="0">
              <a:buNone/>
              <a:defRPr sz="300"/>
            </a:lvl7pPr>
            <a:lvl8pPr marL="1143503" indent="0">
              <a:buNone/>
              <a:defRPr sz="300"/>
            </a:lvl8pPr>
            <a:lvl9pPr marL="1306860" indent="0">
              <a:buNone/>
              <a:defRPr sz="3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60401" y="2001362"/>
            <a:ext cx="1715453" cy="236272"/>
          </a:xfrm>
        </p:spPr>
        <p:txBody>
          <a:bodyPr anchor="b"/>
          <a:lstStyle>
            <a:lvl1pPr algn="l">
              <a:defRPr sz="7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560401" y="255465"/>
            <a:ext cx="1715453" cy="1715453"/>
          </a:xfrm>
        </p:spPr>
        <p:txBody>
          <a:bodyPr/>
          <a:lstStyle>
            <a:lvl1pPr marL="0" indent="0">
              <a:buNone/>
              <a:defRPr sz="1100"/>
            </a:lvl1pPr>
            <a:lvl2pPr marL="163358" indent="0">
              <a:buNone/>
              <a:defRPr sz="1000"/>
            </a:lvl2pPr>
            <a:lvl3pPr marL="326715" indent="0">
              <a:buNone/>
              <a:defRPr sz="900"/>
            </a:lvl3pPr>
            <a:lvl4pPr marL="490073" indent="0">
              <a:buNone/>
              <a:defRPr sz="700"/>
            </a:lvl4pPr>
            <a:lvl5pPr marL="653430" indent="0">
              <a:buNone/>
              <a:defRPr sz="700"/>
            </a:lvl5pPr>
            <a:lvl6pPr marL="816788" indent="0">
              <a:buNone/>
              <a:defRPr sz="700"/>
            </a:lvl6pPr>
            <a:lvl7pPr marL="980145" indent="0">
              <a:buNone/>
              <a:defRPr sz="700"/>
            </a:lvl7pPr>
            <a:lvl8pPr marL="1143503" indent="0">
              <a:buNone/>
              <a:defRPr sz="700"/>
            </a:lvl8pPr>
            <a:lvl9pPr marL="1306860" indent="0">
              <a:buNone/>
              <a:defRPr sz="7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560401" y="2237633"/>
            <a:ext cx="1715453" cy="335546"/>
          </a:xfrm>
        </p:spPr>
        <p:txBody>
          <a:bodyPr/>
          <a:lstStyle>
            <a:lvl1pPr marL="0" indent="0">
              <a:buNone/>
              <a:defRPr sz="500"/>
            </a:lvl1pPr>
            <a:lvl2pPr marL="163358" indent="0">
              <a:buNone/>
              <a:defRPr sz="400"/>
            </a:lvl2pPr>
            <a:lvl3pPr marL="326715" indent="0">
              <a:buNone/>
              <a:defRPr sz="400"/>
            </a:lvl3pPr>
            <a:lvl4pPr marL="490073" indent="0">
              <a:buNone/>
              <a:defRPr sz="300"/>
            </a:lvl4pPr>
            <a:lvl5pPr marL="653430" indent="0">
              <a:buNone/>
              <a:defRPr sz="300"/>
            </a:lvl5pPr>
            <a:lvl6pPr marL="816788" indent="0">
              <a:buNone/>
              <a:defRPr sz="300"/>
            </a:lvl6pPr>
            <a:lvl7pPr marL="980145" indent="0">
              <a:buNone/>
              <a:defRPr sz="300"/>
            </a:lvl7pPr>
            <a:lvl8pPr marL="1143503" indent="0">
              <a:buNone/>
              <a:defRPr sz="300"/>
            </a:lvl8pPr>
            <a:lvl9pPr marL="1306860" indent="0">
              <a:buNone/>
              <a:defRPr sz="3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142955" y="114496"/>
            <a:ext cx="2573179" cy="476515"/>
          </a:xfrm>
          <a:prstGeom prst="rect">
            <a:avLst/>
          </a:prstGeom>
        </p:spPr>
        <p:txBody>
          <a:bodyPr vert="horz" lIns="32672" tIns="16336" rIns="32672" bIns="16336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142955" y="667121"/>
            <a:ext cx="2573179" cy="1886866"/>
          </a:xfrm>
          <a:prstGeom prst="rect">
            <a:avLst/>
          </a:prstGeom>
        </p:spPr>
        <p:txBody>
          <a:bodyPr vert="horz" lIns="32672" tIns="16336" rIns="32672" bIns="16336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142954" y="2649951"/>
            <a:ext cx="667121" cy="152220"/>
          </a:xfrm>
          <a:prstGeom prst="rect">
            <a:avLst/>
          </a:prstGeom>
        </p:spPr>
        <p:txBody>
          <a:bodyPr vert="horz" lIns="32672" tIns="16336" rIns="32672" bIns="16336" rtlCol="0" anchor="ctr"/>
          <a:lstStyle>
            <a:lvl1pPr algn="l">
              <a:defRPr sz="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17/3/2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976855" y="2649951"/>
            <a:ext cx="905378" cy="152220"/>
          </a:xfrm>
          <a:prstGeom prst="rect">
            <a:avLst/>
          </a:prstGeom>
        </p:spPr>
        <p:txBody>
          <a:bodyPr vert="horz" lIns="32672" tIns="16336" rIns="32672" bIns="16336" rtlCol="0" anchor="ctr"/>
          <a:lstStyle>
            <a:lvl1pPr algn="ctr">
              <a:defRPr sz="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2049013" y="2649951"/>
            <a:ext cx="667121" cy="152220"/>
          </a:xfrm>
          <a:prstGeom prst="rect">
            <a:avLst/>
          </a:prstGeom>
        </p:spPr>
        <p:txBody>
          <a:bodyPr vert="horz" lIns="32672" tIns="16336" rIns="32672" bIns="16336" rtlCol="0" anchor="ctr"/>
          <a:lstStyle>
            <a:lvl1pPr algn="r">
              <a:defRPr sz="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26715" rtl="0" eaLnBrk="1" latinLnBrk="0" hangingPunct="1">
        <a:spcBef>
          <a:spcPct val="0"/>
        </a:spcBef>
        <a:buNone/>
        <a:defRPr kumimoji="1" sz="1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2518" indent="-122518" algn="l" defTabSz="326715" rtl="0" eaLnBrk="1" latinLnBrk="0" hangingPunct="1">
        <a:spcBef>
          <a:spcPct val="20000"/>
        </a:spcBef>
        <a:buFont typeface="Arial" pitchFamily="34" charset="0"/>
        <a:buChar char="•"/>
        <a:defRPr kumimoji="1" sz="1100" kern="1200">
          <a:solidFill>
            <a:schemeClr val="tx1"/>
          </a:solidFill>
          <a:latin typeface="+mn-lt"/>
          <a:ea typeface="+mn-ea"/>
          <a:cs typeface="+mn-cs"/>
        </a:defRPr>
      </a:lvl1pPr>
      <a:lvl2pPr marL="265456" indent="-102098" algn="l" defTabSz="326715" rtl="0" eaLnBrk="1" latinLnBrk="0" hangingPunct="1">
        <a:spcBef>
          <a:spcPct val="20000"/>
        </a:spcBef>
        <a:buFont typeface="Arial" pitchFamily="34" charset="0"/>
        <a:buChar char="–"/>
        <a:defRPr kumimoji="1" sz="1000" kern="1200">
          <a:solidFill>
            <a:schemeClr val="tx1"/>
          </a:solidFill>
          <a:latin typeface="+mn-lt"/>
          <a:ea typeface="+mn-ea"/>
          <a:cs typeface="+mn-cs"/>
        </a:defRPr>
      </a:lvl2pPr>
      <a:lvl3pPr marL="408394" indent="-81679" algn="l" defTabSz="326715" rtl="0" eaLnBrk="1" latinLnBrk="0" hangingPunct="1">
        <a:spcBef>
          <a:spcPct val="20000"/>
        </a:spcBef>
        <a:buFont typeface="Arial" pitchFamily="34" charset="0"/>
        <a:buChar char="•"/>
        <a:defRPr kumimoji="1" sz="900" kern="1200">
          <a:solidFill>
            <a:schemeClr val="tx1"/>
          </a:solidFill>
          <a:latin typeface="+mn-lt"/>
          <a:ea typeface="+mn-ea"/>
          <a:cs typeface="+mn-cs"/>
        </a:defRPr>
      </a:lvl3pPr>
      <a:lvl4pPr marL="571751" indent="-81679" algn="l" defTabSz="326715" rtl="0" eaLnBrk="1" latinLnBrk="0" hangingPunct="1">
        <a:spcBef>
          <a:spcPct val="20000"/>
        </a:spcBef>
        <a:buFont typeface="Arial" pitchFamily="34" charset="0"/>
        <a:buChar char="–"/>
        <a:defRPr kumimoji="1" sz="700" kern="1200">
          <a:solidFill>
            <a:schemeClr val="tx1"/>
          </a:solidFill>
          <a:latin typeface="+mn-lt"/>
          <a:ea typeface="+mn-ea"/>
          <a:cs typeface="+mn-cs"/>
        </a:defRPr>
      </a:lvl4pPr>
      <a:lvl5pPr marL="735109" indent="-81679" algn="l" defTabSz="326715" rtl="0" eaLnBrk="1" latinLnBrk="0" hangingPunct="1">
        <a:spcBef>
          <a:spcPct val="20000"/>
        </a:spcBef>
        <a:buFont typeface="Arial" pitchFamily="34" charset="0"/>
        <a:buChar char="»"/>
        <a:defRPr kumimoji="1" sz="700" kern="1200">
          <a:solidFill>
            <a:schemeClr val="tx1"/>
          </a:solidFill>
          <a:latin typeface="+mn-lt"/>
          <a:ea typeface="+mn-ea"/>
          <a:cs typeface="+mn-cs"/>
        </a:defRPr>
      </a:lvl5pPr>
      <a:lvl6pPr marL="898467" indent="-81679" algn="l" defTabSz="326715" rtl="0" eaLnBrk="1" latinLnBrk="0" hangingPunct="1">
        <a:spcBef>
          <a:spcPct val="20000"/>
        </a:spcBef>
        <a:buFont typeface="Arial" pitchFamily="34" charset="0"/>
        <a:buChar char="•"/>
        <a:defRPr kumimoji="1" sz="700" kern="1200">
          <a:solidFill>
            <a:schemeClr val="tx1"/>
          </a:solidFill>
          <a:latin typeface="+mn-lt"/>
          <a:ea typeface="+mn-ea"/>
          <a:cs typeface="+mn-cs"/>
        </a:defRPr>
      </a:lvl6pPr>
      <a:lvl7pPr marL="1061824" indent="-81679" algn="l" defTabSz="326715" rtl="0" eaLnBrk="1" latinLnBrk="0" hangingPunct="1">
        <a:spcBef>
          <a:spcPct val="20000"/>
        </a:spcBef>
        <a:buFont typeface="Arial" pitchFamily="34" charset="0"/>
        <a:buChar char="•"/>
        <a:defRPr kumimoji="1" sz="700" kern="1200">
          <a:solidFill>
            <a:schemeClr val="tx1"/>
          </a:solidFill>
          <a:latin typeface="+mn-lt"/>
          <a:ea typeface="+mn-ea"/>
          <a:cs typeface="+mn-cs"/>
        </a:defRPr>
      </a:lvl7pPr>
      <a:lvl8pPr marL="1225182" indent="-81679" algn="l" defTabSz="326715" rtl="0" eaLnBrk="1" latinLnBrk="0" hangingPunct="1">
        <a:spcBef>
          <a:spcPct val="20000"/>
        </a:spcBef>
        <a:buFont typeface="Arial" pitchFamily="34" charset="0"/>
        <a:buChar char="•"/>
        <a:defRPr kumimoji="1" sz="700" kern="1200">
          <a:solidFill>
            <a:schemeClr val="tx1"/>
          </a:solidFill>
          <a:latin typeface="+mn-lt"/>
          <a:ea typeface="+mn-ea"/>
          <a:cs typeface="+mn-cs"/>
        </a:defRPr>
      </a:lvl8pPr>
      <a:lvl9pPr marL="1388539" indent="-81679" algn="l" defTabSz="326715" rtl="0" eaLnBrk="1" latinLnBrk="0" hangingPunct="1">
        <a:spcBef>
          <a:spcPct val="20000"/>
        </a:spcBef>
        <a:buFont typeface="Arial" pitchFamily="34" charset="0"/>
        <a:buChar char="•"/>
        <a:defRPr kumimoji="1" sz="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326715" rtl="0" eaLnBrk="1" latinLnBrk="0" hangingPunct="1">
        <a:defRPr kumimoji="1" sz="600" kern="1200">
          <a:solidFill>
            <a:schemeClr val="tx1"/>
          </a:solidFill>
          <a:latin typeface="+mn-lt"/>
          <a:ea typeface="+mn-ea"/>
          <a:cs typeface="+mn-cs"/>
        </a:defRPr>
      </a:lvl1pPr>
      <a:lvl2pPr marL="163358" algn="l" defTabSz="326715" rtl="0" eaLnBrk="1" latinLnBrk="0" hangingPunct="1">
        <a:defRPr kumimoji="1" sz="600" kern="1200">
          <a:solidFill>
            <a:schemeClr val="tx1"/>
          </a:solidFill>
          <a:latin typeface="+mn-lt"/>
          <a:ea typeface="+mn-ea"/>
          <a:cs typeface="+mn-cs"/>
        </a:defRPr>
      </a:lvl2pPr>
      <a:lvl3pPr marL="326715" algn="l" defTabSz="326715" rtl="0" eaLnBrk="1" latinLnBrk="0" hangingPunct="1">
        <a:defRPr kumimoji="1" sz="600" kern="1200">
          <a:solidFill>
            <a:schemeClr val="tx1"/>
          </a:solidFill>
          <a:latin typeface="+mn-lt"/>
          <a:ea typeface="+mn-ea"/>
          <a:cs typeface="+mn-cs"/>
        </a:defRPr>
      </a:lvl3pPr>
      <a:lvl4pPr marL="490073" algn="l" defTabSz="326715" rtl="0" eaLnBrk="1" latinLnBrk="0" hangingPunct="1">
        <a:defRPr kumimoji="1" sz="600" kern="1200">
          <a:solidFill>
            <a:schemeClr val="tx1"/>
          </a:solidFill>
          <a:latin typeface="+mn-lt"/>
          <a:ea typeface="+mn-ea"/>
          <a:cs typeface="+mn-cs"/>
        </a:defRPr>
      </a:lvl4pPr>
      <a:lvl5pPr marL="653430" algn="l" defTabSz="326715" rtl="0" eaLnBrk="1" latinLnBrk="0" hangingPunct="1">
        <a:defRPr kumimoji="1" sz="600" kern="1200">
          <a:solidFill>
            <a:schemeClr val="tx1"/>
          </a:solidFill>
          <a:latin typeface="+mn-lt"/>
          <a:ea typeface="+mn-ea"/>
          <a:cs typeface="+mn-cs"/>
        </a:defRPr>
      </a:lvl5pPr>
      <a:lvl6pPr marL="816788" algn="l" defTabSz="326715" rtl="0" eaLnBrk="1" latinLnBrk="0" hangingPunct="1">
        <a:defRPr kumimoji="1" sz="600" kern="1200">
          <a:solidFill>
            <a:schemeClr val="tx1"/>
          </a:solidFill>
          <a:latin typeface="+mn-lt"/>
          <a:ea typeface="+mn-ea"/>
          <a:cs typeface="+mn-cs"/>
        </a:defRPr>
      </a:lvl6pPr>
      <a:lvl7pPr marL="980145" algn="l" defTabSz="326715" rtl="0" eaLnBrk="1" latinLnBrk="0" hangingPunct="1">
        <a:defRPr kumimoji="1" sz="600" kern="1200">
          <a:solidFill>
            <a:schemeClr val="tx1"/>
          </a:solidFill>
          <a:latin typeface="+mn-lt"/>
          <a:ea typeface="+mn-ea"/>
          <a:cs typeface="+mn-cs"/>
        </a:defRPr>
      </a:lvl7pPr>
      <a:lvl8pPr marL="1143503" algn="l" defTabSz="326715" rtl="0" eaLnBrk="1" latinLnBrk="0" hangingPunct="1">
        <a:defRPr kumimoji="1" sz="600" kern="1200">
          <a:solidFill>
            <a:schemeClr val="tx1"/>
          </a:solidFill>
          <a:latin typeface="+mn-lt"/>
          <a:ea typeface="+mn-ea"/>
          <a:cs typeface="+mn-cs"/>
        </a:defRPr>
      </a:lvl8pPr>
      <a:lvl9pPr marL="1306860" algn="l" defTabSz="326715" rtl="0" eaLnBrk="1" latinLnBrk="0" hangingPunct="1">
        <a:defRPr kumimoji="1" sz="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テキスト ボックス 87"/>
          <p:cNvSpPr txBox="1"/>
          <p:nvPr/>
        </p:nvSpPr>
        <p:spPr>
          <a:xfrm>
            <a:off x="61392" y="377535"/>
            <a:ext cx="514233" cy="794057"/>
          </a:xfrm>
          <a:prstGeom prst="rect">
            <a:avLst/>
          </a:prstGeom>
          <a:noFill/>
        </p:spPr>
        <p:txBody>
          <a:bodyPr vert="vert270" wrap="square" lIns="92070" tIns="46035" rIns="92070" bIns="46035" rtlCol="0">
            <a:spAutoFit/>
          </a:bodyPr>
          <a:lstStyle/>
          <a:p>
            <a:pPr algn="ctr"/>
            <a:r>
              <a:rPr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Tumor </a:t>
            </a:r>
            <a:r>
              <a:rPr lang="en-US" altLang="ja-JP" sz="8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volume (mm</a:t>
            </a:r>
            <a:r>
              <a:rPr lang="en-US" altLang="ja-JP" sz="800" b="1" baseline="30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3</a:t>
            </a:r>
            <a:r>
              <a:rPr lang="en-US" altLang="ja-JP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)</a:t>
            </a:r>
            <a:endParaRPr lang="ja-JP" altLang="en-US" sz="800" b="1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  <a:p>
            <a:pPr algn="ctr"/>
            <a:endParaRPr lang="ja-JP" altLang="en-US" sz="800" b="1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89" name="テキスト ボックス 88"/>
          <p:cNvSpPr txBox="1"/>
          <p:nvPr/>
        </p:nvSpPr>
        <p:spPr>
          <a:xfrm>
            <a:off x="2062376" y="1357536"/>
            <a:ext cx="503632" cy="216080"/>
          </a:xfrm>
          <a:prstGeom prst="rect">
            <a:avLst/>
          </a:prstGeom>
          <a:noFill/>
        </p:spPr>
        <p:txBody>
          <a:bodyPr wrap="square" lIns="92070" tIns="46035" rIns="92070" bIns="46035" rtlCol="0">
            <a:spAutoFit/>
          </a:bodyPr>
          <a:lstStyle/>
          <a:p>
            <a:r>
              <a:rPr lang="en-US" altLang="ja-JP" sz="8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Days)</a:t>
            </a:r>
            <a:endParaRPr lang="ja-JP" altLang="en-US" sz="800" b="1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90" name="左右矢印 89"/>
          <p:cNvSpPr/>
          <p:nvPr/>
        </p:nvSpPr>
        <p:spPr>
          <a:xfrm>
            <a:off x="792520" y="1416127"/>
            <a:ext cx="754748" cy="45719"/>
          </a:xfrm>
          <a:prstGeom prst="leftRightArrow">
            <a:avLst/>
          </a:prstGeom>
          <a:solidFill>
            <a:schemeClr val="tx1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0754" tIns="45377" rIns="90754" bIns="45377" rtlCol="0" anchor="ctr"/>
          <a:lstStyle/>
          <a:p>
            <a:pPr algn="ctr"/>
            <a:endParaRPr lang="ja-JP" altLang="en-US" sz="700" b="1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91" name="テキスト ボックス 90"/>
          <p:cNvSpPr txBox="1"/>
          <p:nvPr/>
        </p:nvSpPr>
        <p:spPr>
          <a:xfrm>
            <a:off x="712892" y="1431367"/>
            <a:ext cx="10388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Drug treatment</a:t>
            </a:r>
            <a:endParaRPr kumimoji="1" lang="ja-JP" altLang="en-US" sz="8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9" name="テキスト ボックス 2"/>
          <p:cNvSpPr txBox="1"/>
          <p:nvPr/>
        </p:nvSpPr>
        <p:spPr>
          <a:xfrm>
            <a:off x="-66793" y="-25515"/>
            <a:ext cx="10881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164484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328969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493454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57937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822421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986906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151390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315873" algn="l" defTabSz="328969" rtl="0" eaLnBrk="1" latinLnBrk="0" hangingPunct="1">
              <a:defRPr kumimoji="1" sz="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8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Supp</a:t>
            </a:r>
            <a:r>
              <a:rPr kumimoji="1" lang="en-US" altLang="ja-JP" sz="8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Figure6</a:t>
            </a:r>
            <a:endParaRPr kumimoji="1" lang="ja-JP" altLang="en-US" sz="8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0" y="133400"/>
            <a:ext cx="543572" cy="339816"/>
          </a:xfrm>
          <a:prstGeom prst="rect">
            <a:avLst/>
          </a:prstGeom>
          <a:noFill/>
        </p:spPr>
        <p:txBody>
          <a:bodyPr wrap="square" lIns="184131" tIns="92065" rIns="184131" bIns="92065" rtlCol="0">
            <a:spAutoFit/>
          </a:bodyPr>
          <a:lstStyle/>
          <a:p>
            <a:r>
              <a:rPr kumimoji="1" lang="en-US" altLang="ja-JP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A</a:t>
            </a:r>
            <a:endParaRPr kumimoji="1" lang="ja-JP" altLang="en-US" sz="1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3330" y="1429544"/>
            <a:ext cx="543572" cy="339816"/>
          </a:xfrm>
          <a:prstGeom prst="rect">
            <a:avLst/>
          </a:prstGeom>
          <a:noFill/>
        </p:spPr>
        <p:txBody>
          <a:bodyPr wrap="square" lIns="184131" tIns="92065" rIns="184131" bIns="92065" rtlCol="0">
            <a:spAutoFit/>
          </a:bodyPr>
          <a:lstStyle/>
          <a:p>
            <a:r>
              <a:rPr lang="en-US" altLang="ja-JP" sz="1000" b="1" dirty="0">
                <a:latin typeface="Helvetica" panose="020B0604020202020204" pitchFamily="34" charset="0"/>
                <a:cs typeface="Helvetica" panose="020B0604020202020204" pitchFamily="34" charset="0"/>
              </a:rPr>
              <a:t>B</a:t>
            </a:r>
            <a:endParaRPr kumimoji="1" lang="ja-JP" altLang="en-US" sz="10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9" name="テキスト ボックス 18"/>
          <p:cNvSpPr txBox="1">
            <a:spLocks noChangeArrowheads="1"/>
          </p:cNvSpPr>
          <p:nvPr/>
        </p:nvSpPr>
        <p:spPr bwMode="auto">
          <a:xfrm rot="16200000">
            <a:off x="-120146" y="1915776"/>
            <a:ext cx="883793" cy="199362"/>
          </a:xfrm>
          <a:prstGeom prst="rect">
            <a:avLst/>
          </a:prstGeom>
          <a:noFill/>
          <a:ln>
            <a:noFill/>
          </a:ln>
          <a:extLst/>
        </p:spPr>
        <p:txBody>
          <a:bodyPr wrap="none" lIns="90754" tIns="45377" rIns="90754" bIns="45377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>
              <a:defRPr/>
            </a:pPr>
            <a:r>
              <a:rPr lang="en-US" altLang="ja-JP" sz="700" b="1" dirty="0">
                <a:latin typeface="Helvetica" panose="020B0604020202020204" pitchFamily="34" charset="0"/>
                <a:ea typeface="+mn-ea"/>
                <a:cs typeface="Helvetica" panose="020B0604020202020204" pitchFamily="34" charset="0"/>
              </a:rPr>
              <a:t>Body </a:t>
            </a:r>
            <a:r>
              <a:rPr lang="en-US" altLang="ja-JP" sz="700" b="1" dirty="0" smtClean="0">
                <a:latin typeface="Helvetica" panose="020B0604020202020204" pitchFamily="34" charset="0"/>
                <a:ea typeface="+mn-ea"/>
                <a:cs typeface="Helvetica" panose="020B0604020202020204" pitchFamily="34" charset="0"/>
              </a:rPr>
              <a:t>weight (g) </a:t>
            </a:r>
            <a:endParaRPr lang="ja-JP" altLang="en-US" sz="700" b="1" dirty="0">
              <a:latin typeface="Helvetica" panose="020B0604020202020204" pitchFamily="34" charset="0"/>
              <a:ea typeface="+mn-ea"/>
              <a:cs typeface="Helvetica" panose="020B0604020202020204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2085236" y="2581672"/>
            <a:ext cx="503632" cy="216080"/>
          </a:xfrm>
          <a:prstGeom prst="rect">
            <a:avLst/>
          </a:prstGeom>
          <a:noFill/>
        </p:spPr>
        <p:txBody>
          <a:bodyPr wrap="square" lIns="92070" tIns="46035" rIns="92070" bIns="46035" rtlCol="0">
            <a:spAutoFit/>
          </a:bodyPr>
          <a:lstStyle/>
          <a:p>
            <a:r>
              <a:rPr lang="en-US" altLang="ja-JP" sz="8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(Days)</a:t>
            </a:r>
            <a:endParaRPr lang="ja-JP" altLang="en-US" sz="800" b="1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1" name="左右矢印 20"/>
          <p:cNvSpPr/>
          <p:nvPr/>
        </p:nvSpPr>
        <p:spPr>
          <a:xfrm>
            <a:off x="807760" y="2654260"/>
            <a:ext cx="754748" cy="45719"/>
          </a:xfrm>
          <a:prstGeom prst="leftRightArrow">
            <a:avLst/>
          </a:prstGeom>
          <a:solidFill>
            <a:schemeClr val="tx1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0754" tIns="45377" rIns="90754" bIns="45377" rtlCol="0" anchor="ctr"/>
          <a:lstStyle/>
          <a:p>
            <a:pPr algn="ctr"/>
            <a:endParaRPr lang="ja-JP" altLang="en-US" sz="700" b="1" dirty="0">
              <a:solidFill>
                <a:schemeClr val="bg1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728132" y="2669500"/>
            <a:ext cx="10388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Drug treatment</a:t>
            </a:r>
            <a:endParaRPr kumimoji="1" lang="ja-JP" altLang="en-US" sz="8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aphicFrame>
        <p:nvGraphicFramePr>
          <p:cNvPr id="15" name="グラフ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75127237"/>
              </p:ext>
            </p:extLst>
          </p:nvPr>
        </p:nvGraphicFramePr>
        <p:xfrm>
          <a:off x="477287" y="168824"/>
          <a:ext cx="2011588" cy="12522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6" name="グラフ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4971607"/>
              </p:ext>
            </p:extLst>
          </p:nvPr>
        </p:nvGraphicFramePr>
        <p:xfrm>
          <a:off x="575625" y="1635125"/>
          <a:ext cx="1934040" cy="10276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8204521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</TotalTime>
  <Words>24</Words>
  <Application>Microsoft Office PowerPoint</Application>
  <PresentationFormat>ユーザー設定</PresentationFormat>
  <Paragraphs>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Helvetica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enichiro</dc:creator>
  <cp:lastModifiedBy>kadoaki</cp:lastModifiedBy>
  <cp:revision>24</cp:revision>
  <dcterms:created xsi:type="dcterms:W3CDTF">2016-08-27T13:38:19Z</dcterms:created>
  <dcterms:modified xsi:type="dcterms:W3CDTF">2017-03-26T02:54:29Z</dcterms:modified>
</cp:coreProperties>
</file>